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1241E6-6942-4A7A-A7A5-7AAAFA0045F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3A79AD-5C2D-4967-B0C3-DE270991159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2DD0CC-8E33-445B-A8E5-BEA1A6FEB19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921923-AB95-48E5-9456-59A37A59FC3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10427F-DDD9-4D38-9A24-CCF3362D87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34B7DC-4EEC-4457-9817-5D7300E602C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DCFB50-D4E8-4F1E-B023-2962682C8EA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4909AA-BB73-4430-B279-74E8673C9B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257DFC-C0A7-4973-BAEB-366F7E66DC5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2D5D6D-90CF-4D6F-A3C2-127B64FF6B0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AD8546-A273-4251-A949-87C2EF0B73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49106F-58D6-4C98-8648-7013C97B52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5B81092-48CF-4253-8455-2D3655806D15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2"/>
          <p:cNvSpPr/>
          <p:nvPr/>
        </p:nvSpPr>
        <p:spPr>
          <a:xfrm>
            <a:off x="307080" y="1301760"/>
            <a:ext cx="3679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atients who received chemotherapy (n=60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485640" y="2239920"/>
          <a:ext cx="5646960" cy="1820880"/>
        </p:xfrm>
        <a:graphic>
          <a:graphicData uri="http://schemas.openxmlformats.org/drawingml/2006/table">
            <a:tbl>
              <a:tblPr/>
              <a:tblGrid>
                <a:gridCol w="1605240"/>
                <a:gridCol w="1495440"/>
                <a:gridCol w="680760"/>
                <a:gridCol w="358920"/>
                <a:gridCol w="1160280"/>
                <a:gridCol w="346320"/>
              </a:tblGrid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inical-pathological parameter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ro-RO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ivariate analysi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ro-RO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ltivariate analysi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da-DK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-stage (n=60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092 (1.607, 10.418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0.00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9.83 (2.69, 35.916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0.00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ymph-node involvement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546 (0.556, 4.296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0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535 (0.777, 8.265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2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istological typ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471 (0.577, 10.578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8.517 (1.607, 213.416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  <a:ea typeface="Arial"/>
                        </a:rPr>
                        <a:t>0.01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pt-BR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strogen receptor status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33 (0.392, 2.217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7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194 (0.494, 9.75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0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 statu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23 (0.258, 1.504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9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15 (0.116, 2.289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8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ytoplasm Score of OTU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026 (0.443, 2.379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5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822 (1.121, 13.036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  <a:ea typeface="Arial"/>
                        </a:rPr>
                        <a:t>0.03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3" name="TextBox 16"/>
          <p:cNvSpPr/>
          <p:nvPr/>
        </p:nvSpPr>
        <p:spPr>
          <a:xfrm>
            <a:off x="422280" y="1938240"/>
            <a:ext cx="1265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TextBox 17"/>
          <p:cNvSpPr/>
          <p:nvPr/>
        </p:nvSpPr>
        <p:spPr>
          <a:xfrm>
            <a:off x="424800" y="4464000"/>
            <a:ext cx="189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Disease-specific survival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5" name=""/>
          <p:cNvGraphicFramePr/>
          <p:nvPr/>
        </p:nvGraphicFramePr>
        <p:xfrm>
          <a:off x="485640" y="4746600"/>
          <a:ext cx="5659560" cy="1820880"/>
        </p:xfrm>
        <a:graphic>
          <a:graphicData uri="http://schemas.openxmlformats.org/drawingml/2006/table">
            <a:tbl>
              <a:tblPr/>
              <a:tblGrid>
                <a:gridCol w="1738440"/>
                <a:gridCol w="1208160"/>
                <a:gridCol w="838080"/>
                <a:gridCol w="345960"/>
                <a:gridCol w="1047960"/>
                <a:gridCol w="480960"/>
              </a:tblGrid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linical-pathological parameter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ro-RO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Univariate analysi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ro-RO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ultivariate analysi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R (95% CI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RR (95% CI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i="1" lang="en-US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da-DK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-stage (n=60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4.505 (1.734, 11.64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</a:rPr>
                        <a:t>0.00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.83 (2.69, 35.916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</a:rPr>
                        <a:t>0.001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Lymph-node involvement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934 (0.636, 5.88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45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535 (0.777, 8.265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histological typ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226 (0.516, 9.602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28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.517 (1.607, 213.416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dd0806"/>
                          </a:solidFill>
                          <a:latin typeface="Arial"/>
                        </a:rPr>
                        <a:t>0.01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pt-B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Estrogen receptor status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56 (0.384, 2.381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92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.194 (0.494, 9.75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0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PR status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727 (0.292, 1.81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49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.515 (0.116, 2.289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83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30320"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ytoplasm Score of OTUB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.029 (0.426, 2.487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6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49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.822 (1.121, 13.036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8280" rIns="8280" tIns="8280" bIns="0" anchor="b">
                      <a:noAutofit/>
                    </a:bodyPr>
                    <a:p>
                      <a:pPr algn="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600" spc="-1" strike="noStrike">
                          <a:solidFill>
                            <a:srgbClr val="ff0000"/>
                          </a:solidFill>
                          <a:latin typeface="Arial"/>
                        </a:rPr>
                        <a:t>0.032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280" marR="828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6" name="TextBox 19"/>
          <p:cNvSpPr/>
          <p:nvPr/>
        </p:nvSpPr>
        <p:spPr>
          <a:xfrm>
            <a:off x="4640040" y="9597960"/>
            <a:ext cx="2302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22T21:29:58Z</dcterms:created>
  <dc:creator>Eric Lam</dc:creator>
  <dc:description/>
  <dc:language>en-US</dc:language>
  <cp:lastModifiedBy>Satish.d</cp:lastModifiedBy>
  <cp:lastPrinted>2015-03-23T10:24:39Z</cp:lastPrinted>
  <dcterms:modified xsi:type="dcterms:W3CDTF">2015-06-25T11:25:48Z</dcterms:modified>
  <cp:revision>919</cp:revision>
  <dc:subject/>
  <dc:title>PowerPoint Presentation</dc:title>
</cp:coreProperties>
</file>